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5FF4B-8AE6-42C1-A60F-B4922096CA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772F91-33E7-4069-8C0B-D70DBAE3A8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91654-F964-40B9-A858-A99375CFCB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BFB36-063C-42CB-89BF-1805A6EFAF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9B84B4-80D6-4687-9E2D-2A703D313B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C99C7E-AA7A-4DB4-8E1C-7029658364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F20EF-8E8F-40ED-AF62-C53AC34A85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2DB30-ADFC-406A-8F67-153B3AFCF4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E4F7F-BF62-4A6F-AAC2-4733B5E563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C0034E-F7FD-46CD-92B9-6D84D57017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CE90D-CBAE-409F-B656-DD2A986586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6BF3C-193F-4CF7-8DF3-FF072C19A7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7A736B-7968-481C-9396-C49228E5CDC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2.wmf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8"/>
          <p:cNvGrpSpPr/>
          <p:nvPr/>
        </p:nvGrpSpPr>
        <p:grpSpPr>
          <a:xfrm>
            <a:off x="79200" y="406440"/>
            <a:ext cx="6756480" cy="7645320"/>
            <a:chOff x="79200" y="406440"/>
            <a:chExt cx="6756480" cy="7645320"/>
          </a:xfrm>
        </p:grpSpPr>
        <p:grpSp>
          <p:nvGrpSpPr>
            <p:cNvPr id="42" name="Group 17"/>
            <p:cNvGrpSpPr/>
            <p:nvPr/>
          </p:nvGrpSpPr>
          <p:grpSpPr>
            <a:xfrm>
              <a:off x="79200" y="406440"/>
              <a:ext cx="6756480" cy="7645320"/>
              <a:chOff x="79200" y="406440"/>
              <a:chExt cx="6756480" cy="7645320"/>
            </a:xfrm>
          </p:grpSpPr>
          <p:pic>
            <p:nvPicPr>
              <p:cNvPr id="43" name="Picture 6" descr="29-11-11 yf ivt dilutions.tif"/>
              <p:cNvPicPr/>
              <p:nvPr/>
            </p:nvPicPr>
            <p:blipFill>
              <a:blip r:embed="rId1"/>
              <a:srcRect l="15001" t="53106" r="30729" b="32504"/>
              <a:stretch/>
            </p:blipFill>
            <p:spPr>
              <a:xfrm>
                <a:off x="936720" y="7239240"/>
                <a:ext cx="4397400" cy="8125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graphicFrame>
            <p:nvGraphicFramePr>
              <p:cNvPr id="44" name="Object 4"/>
              <p:cNvGraphicFramePr/>
              <p:nvPr/>
            </p:nvGraphicFramePr>
            <p:xfrm>
              <a:off x="879480" y="406440"/>
              <a:ext cx="4324320" cy="3665520"/>
            </p:xfrm>
            <a:graphic>
              <a:graphicData uri="http://schemas.openxmlformats.org/presentationml/2006/ole">
                <p:oleObj progId="Excel.Sheet.12" r:id="rId2" spid="">
                  <p:embed/>
                  <p:pic>
                    <p:nvPicPr>
                      <p:cNvPr id="45" name="Object 4" descr=""/>
                      <p:cNvPicPr/>
                      <p:nvPr/>
                    </p:nvPicPr>
                    <p:blipFill>
                      <a:blip r:embed="rId3"/>
                      <a:stretch/>
                    </p:blipFill>
                    <p:spPr>
                      <a:xfrm>
                        <a:off x="879480" y="406440"/>
                        <a:ext cx="4324320" cy="3665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46" name="TextBox 4"/>
              <p:cNvSpPr/>
              <p:nvPr/>
            </p:nvSpPr>
            <p:spPr>
              <a:xfrm>
                <a:off x="79200" y="468000"/>
                <a:ext cx="473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A.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Box 5"/>
              <p:cNvSpPr/>
              <p:nvPr/>
            </p:nvSpPr>
            <p:spPr>
              <a:xfrm>
                <a:off x="79200" y="4419720"/>
                <a:ext cx="473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B.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 Box 11"/>
              <p:cNvSpPr/>
              <p:nvPr/>
            </p:nvSpPr>
            <p:spPr>
              <a:xfrm>
                <a:off x="5181480" y="4251240"/>
                <a:ext cx="1654200" cy="2682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1-    3X10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8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opi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2-    3X10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7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opi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3-    3X10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6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opi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4-    3X10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5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opi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5-    3X10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4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opi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6-    3X10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3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opi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7-    3X10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opi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8-    3X10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opi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9-    3X10</a:t>
                </a:r>
                <a:r>
                  <a:rPr b="0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opi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49" name="Straight Arrow Connector 10"/>
              <p:cNvCxnSpPr/>
              <p:nvPr/>
            </p:nvCxnSpPr>
            <p:spPr>
              <a:xfrm>
                <a:off x="777600" y="7481880"/>
                <a:ext cx="153000" cy="2160"/>
              </a:xfrm>
              <a:prstGeom prst="straightConnector1">
                <a:avLst/>
              </a:prstGeom>
              <a:ln w="9360">
                <a:solidFill>
                  <a:srgbClr val="0d0d0d"/>
                </a:solidFill>
                <a:miter/>
                <a:tailEnd len="med" type="arrow" w="med"/>
              </a:ln>
            </p:spPr>
          </p:cxnSp>
          <p:cxnSp>
            <p:nvCxnSpPr>
              <p:cNvPr id="50" name="Straight Arrow Connector 16"/>
              <p:cNvCxnSpPr/>
              <p:nvPr/>
            </p:nvCxnSpPr>
            <p:spPr>
              <a:xfrm>
                <a:off x="777600" y="7869240"/>
                <a:ext cx="153000" cy="2160"/>
              </a:xfrm>
              <a:prstGeom prst="straightConnector1">
                <a:avLst/>
              </a:prstGeom>
              <a:ln w="9360">
                <a:solidFill>
                  <a:srgbClr val="0d0d0d"/>
                </a:solidFill>
                <a:miter/>
                <a:tailEnd len="med" type="arrow" w="med"/>
              </a:ln>
            </p:spPr>
          </p:cxnSp>
          <p:sp>
            <p:nvSpPr>
              <p:cNvPr id="51" name="TextBox 17"/>
              <p:cNvSpPr/>
              <p:nvPr/>
            </p:nvSpPr>
            <p:spPr>
              <a:xfrm>
                <a:off x="207360" y="734544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00 b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Box 18"/>
              <p:cNvSpPr/>
              <p:nvPr/>
            </p:nvSpPr>
            <p:spPr>
              <a:xfrm>
                <a:off x="209160" y="772488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0 b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21"/>
              <p:cNvSpPr/>
              <p:nvPr/>
            </p:nvSpPr>
            <p:spPr>
              <a:xfrm>
                <a:off x="956520" y="7162920"/>
                <a:ext cx="44388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M       1        2       3        4        5       6       7      8      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22"/>
              <p:cNvSpPr/>
              <p:nvPr/>
            </p:nvSpPr>
            <p:spPr>
              <a:xfrm>
                <a:off x="1613880" y="3200400"/>
                <a:ext cx="3224880" cy="246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   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X10</a:t>
                </a:r>
                <a:r>
                  <a:rPr b="0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7 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X10</a:t>
                </a:r>
                <a:r>
                  <a:rPr b="0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6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X10</a:t>
                </a:r>
                <a:r>
                  <a:rPr b="0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5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X10</a:t>
                </a:r>
                <a:r>
                  <a:rPr b="0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4</a:t>
                </a:r>
                <a:r>
                  <a:rPr b="0" lang="en-IN" sz="10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X10</a:t>
                </a:r>
                <a:r>
                  <a:rPr b="0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3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X10</a:t>
                </a:r>
                <a:r>
                  <a:rPr b="0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r>
                  <a:rPr b="0" lang="en-IN" sz="10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X10</a:t>
                </a:r>
                <a:r>
                  <a:rPr b="0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1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55" name="Straight Arrow Connector 24"/>
              <p:cNvCxnSpPr/>
              <p:nvPr/>
            </p:nvCxnSpPr>
            <p:spPr>
              <a:xfrm flipH="1" flipV="1">
                <a:off x="5333400" y="7848360"/>
                <a:ext cx="229320" cy="216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56" name="TextBox 27"/>
              <p:cNvSpPr/>
              <p:nvPr/>
            </p:nvSpPr>
            <p:spPr>
              <a:xfrm>
                <a:off x="5496480" y="771228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13 b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7" name="Picture 5" descr="temp"/>
              <p:cNvPicPr/>
              <p:nvPr/>
            </p:nvPicPr>
            <p:blipFill>
              <a:blip r:embed="rId4"/>
              <a:srcRect l="8846" t="12002" r="6843" b="7431"/>
              <a:stretch/>
            </p:blipFill>
            <p:spPr>
              <a:xfrm>
                <a:off x="883800" y="4396680"/>
                <a:ext cx="4267080" cy="24382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</p:grpSp>
        <p:sp>
          <p:nvSpPr>
            <p:cNvPr id="58" name="TextBox 21"/>
            <p:cNvSpPr/>
            <p:nvPr/>
          </p:nvSpPr>
          <p:spPr>
            <a:xfrm>
              <a:off x="2467080" y="5440680"/>
              <a:ext cx="282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     2        3       4      5   6     7     8     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30T18:12:32Z</dcterms:created>
  <dc:creator>VIRO_OFF</dc:creator>
  <dc:description/>
  <dc:language>en-US</dc:language>
  <cp:lastModifiedBy>drde</cp:lastModifiedBy>
  <dcterms:modified xsi:type="dcterms:W3CDTF">2011-12-06T06:48:33Z</dcterms:modified>
  <cp:revision>15</cp:revision>
  <dc:subject/>
  <dc:title>Slide 1</dc:title>
</cp:coreProperties>
</file>